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96" y="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Φύλλο1!$B$1</c:f>
              <c:strCache>
                <c:ptCount val="1"/>
                <c:pt idx="0">
                  <c:v>Στήλη1</c:v>
                </c:pt>
              </c:strCache>
            </c:strRef>
          </c:tx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BB1-41D0-B7F0-E3EE4C288F46}"/>
              </c:ext>
            </c:extLst>
          </c:dPt>
          <c:dPt>
            <c:idx val="1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BB1-41D0-B7F0-E3EE4C288F46}"/>
              </c:ext>
            </c:extLst>
          </c:dPt>
          <c:cat>
            <c:strRef>
              <c:f>Φύλλο1!$A$2:$A$3</c:f>
              <c:strCache>
                <c:ptCount val="2"/>
                <c:pt idx="0">
                  <c:v>Asian</c:v>
                </c:pt>
                <c:pt idx="1">
                  <c:v>Europe</c:v>
                </c:pt>
              </c:strCache>
            </c:strRef>
          </c:cat>
          <c:val>
            <c:numRef>
              <c:f>Φύλλο1!$B$2:$B$3</c:f>
              <c:numCache>
                <c:formatCode>General</c:formatCode>
                <c:ptCount val="2"/>
                <c:pt idx="0">
                  <c:v>70</c:v>
                </c:pt>
                <c:pt idx="1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B1-41D0-B7F0-E3EE4C288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"/>
          <c:y val="4.4702975107939634E-3"/>
          <c:w val="0.96562499999999996"/>
          <c:h val="0.81052203429367409"/>
        </c:manualLayout>
      </c:layout>
      <c:ofPieChart>
        <c:ofPieType val="pie"/>
        <c:varyColors val="1"/>
        <c:dLbls>
          <c:showLegendKey val="0"/>
          <c:showVal val="0"/>
          <c:showCatName val="0"/>
          <c:showSerName val="0"/>
          <c:showPercent val="0"/>
          <c:showBubbleSize val="0"/>
          <c:showLeaderLines val="0"/>
        </c:dLbls>
        <c:gapWidth val="100"/>
        <c:secondPieSize val="75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485358899136566E-3"/>
          <c:y val="0.35120846132092681"/>
          <c:w val="0.59844708736914998"/>
          <c:h val="0.64879153867907324"/>
        </c:manualLayout>
      </c:layout>
      <c:doughnutChart>
        <c:varyColors val="1"/>
        <c:ser>
          <c:idx val="0"/>
          <c:order val="0"/>
          <c:tx>
            <c:strRef>
              <c:f>Φύλλο1!$B$1</c:f>
              <c:strCache>
                <c:ptCount val="1"/>
                <c:pt idx="0">
                  <c:v>Πωλήσεις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BDD-46F7-8229-E7C767A6D61F}"/>
              </c:ext>
            </c:extLst>
          </c:dPt>
          <c:dPt>
            <c:idx val="1"/>
            <c:bubble3D val="0"/>
            <c:spPr>
              <a:solidFill>
                <a:schemeClr val="accent4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0B2-45E8-93B3-8C93CDC5ABB4}"/>
              </c:ext>
            </c:extLst>
          </c:dPt>
          <c:cat>
            <c:strRef>
              <c:f>Φύλλο1!$A$2:$A$3</c:f>
              <c:strCache>
                <c:ptCount val="2"/>
                <c:pt idx="0">
                  <c:v>Prescribe vitamin D before COVID-19</c:v>
                </c:pt>
                <c:pt idx="1">
                  <c:v>No prescribe vitamin D before COVID-19</c:v>
                </c:pt>
              </c:strCache>
            </c:strRef>
          </c:cat>
          <c:val>
            <c:numRef>
              <c:f>Φύλλο1!$B$2:$B$3</c:f>
              <c:numCache>
                <c:formatCode>General</c:formatCode>
                <c:ptCount val="2"/>
                <c:pt idx="0">
                  <c:v>82.9</c:v>
                </c:pt>
                <c:pt idx="1">
                  <c:v>17.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B2-45E8-93B3-8C93CDC5AB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321286092934444"/>
          <c:y val="0.50855040002042518"/>
          <c:w val="0.34926054102657211"/>
          <c:h val="0.3521647775539834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06987411377905"/>
          <c:y val="0"/>
          <c:w val="0.2572745649503137"/>
          <c:h val="0.51968105852275215"/>
        </c:manualLayout>
      </c:layout>
      <c:doughnutChart>
        <c:varyColors val="1"/>
        <c:ser>
          <c:idx val="0"/>
          <c:order val="0"/>
          <c:tx>
            <c:strRef>
              <c:f>Φύλλο1!$B$1</c:f>
              <c:strCache>
                <c:ptCount val="1"/>
                <c:pt idx="0">
                  <c:v>Στήλη1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082-4E69-ADCF-D05EFC22DAB7}"/>
              </c:ext>
            </c:extLst>
          </c:dPt>
          <c:dPt>
            <c:idx val="1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E7BF-4494-B91C-540F0D331589}"/>
              </c:ext>
            </c:extLst>
          </c:dPt>
          <c:cat>
            <c:strRef>
              <c:f>Φύλλο1!$A$2:$A$3</c:f>
              <c:strCache>
                <c:ptCount val="2"/>
                <c:pt idx="0">
                  <c:v>GPs</c:v>
                </c:pt>
                <c:pt idx="1">
                  <c:v>MS</c:v>
                </c:pt>
              </c:strCache>
            </c:strRef>
          </c:cat>
          <c:val>
            <c:numRef>
              <c:f>Φύλλο1!$B$2:$B$3</c:f>
              <c:numCache>
                <c:formatCode>General</c:formatCode>
                <c:ptCount val="2"/>
                <c:pt idx="0">
                  <c:v>80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BF-4494-B91C-540F0D3315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274026745086665"/>
          <c:y val="0.1527287799706562"/>
          <c:w val="0.17302306642408166"/>
          <c:h val="0.1607178478236687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doughnutChart>
        <c:varyColors val="1"/>
        <c:ser>
          <c:idx val="0"/>
          <c:order val="0"/>
          <c:tx>
            <c:strRef>
              <c:f>Φύλλο1!$B$1</c:f>
              <c:strCache>
                <c:ptCount val="1"/>
                <c:pt idx="0">
                  <c:v>Πωλήσεις</c:v>
                </c:pt>
              </c:strCache>
            </c:strRef>
          </c:tx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E47-4881-8A44-D113E71DAEFD}"/>
              </c:ext>
            </c:extLst>
          </c:dPt>
          <c:dPt>
            <c:idx val="1"/>
            <c:bubble3D val="0"/>
            <c:spPr>
              <a:solidFill>
                <a:schemeClr val="accent5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E47-4881-8A44-D113E71DAEFD}"/>
              </c:ext>
            </c:extLst>
          </c:dPt>
          <c:cat>
            <c:strRef>
              <c:f>Φύλλο1!$A$2:$A$3</c:f>
              <c:strCache>
                <c:ptCount val="2"/>
                <c:pt idx="0">
                  <c:v>Asian GPs</c:v>
                </c:pt>
                <c:pt idx="1">
                  <c:v>Caucasian GPs</c:v>
                </c:pt>
              </c:strCache>
            </c:strRef>
          </c:cat>
          <c:val>
            <c:numRef>
              <c:f>Φύλλο1!$B$2:$B$3</c:f>
              <c:numCache>
                <c:formatCode>General</c:formatCode>
                <c:ptCount val="2"/>
                <c:pt idx="0">
                  <c:v>80</c:v>
                </c:pt>
                <c:pt idx="1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47-4881-8A44-D113E71DAE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75"/>
      </c:doughnut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2724278469087217"/>
          <c:y val="0.81307371048306221"/>
          <c:w val="0.57055385428203287"/>
          <c:h val="0.100149400221884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l-G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Φύλλο1!$B$1</c:f>
              <c:strCache>
                <c:ptCount val="1"/>
                <c:pt idx="0">
                  <c:v>Personal use of vitamin D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D38-4615-A962-22C9D88C7B87}"/>
              </c:ext>
            </c:extLst>
          </c:dPt>
          <c:dPt>
            <c:idx val="1"/>
            <c:bubble3D val="0"/>
            <c:spPr>
              <a:solidFill>
                <a:schemeClr val="tx2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85A0-4569-9B64-0DED897C1469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D38-4615-A962-22C9D88C7B87}"/>
              </c:ext>
            </c:extLst>
          </c:dPt>
          <c:cat>
            <c:strRef>
              <c:f>Φύλλο1!$A$2:$A$4</c:f>
              <c:strCache>
                <c:ptCount val="3"/>
                <c:pt idx="0">
                  <c:v>45-54 years</c:v>
                </c:pt>
                <c:pt idx="1">
                  <c:v>65-74 years </c:v>
                </c:pt>
                <c:pt idx="2">
                  <c:v>18-24 years </c:v>
                </c:pt>
              </c:strCache>
            </c:strRef>
          </c:cat>
          <c:val>
            <c:numRef>
              <c:f>Φύλλο1!$B$2:$B$4</c:f>
              <c:numCache>
                <c:formatCode>General</c:formatCode>
                <c:ptCount val="3"/>
                <c:pt idx="0">
                  <c:v>8.1999999999999993</c:v>
                </c:pt>
                <c:pt idx="1">
                  <c:v>3.2</c:v>
                </c:pt>
                <c:pt idx="2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A0-4569-9B64-0DED897C1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l-G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l-GR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915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271</cdr:x>
      <cdr:y>0.62058</cdr:y>
    </cdr:from>
    <cdr:to>
      <cdr:x>0.66415</cdr:x>
      <cdr:y>0.75255</cdr:y>
    </cdr:to>
    <cdr:cxnSp macro="">
      <cdr:nvCxnSpPr>
        <cdr:cNvPr id="2" name="Γραμμή σύνδεσης: Καμπύλη 1">
          <a:extLst xmlns:a="http://schemas.openxmlformats.org/drawingml/2006/main">
            <a:ext uri="{FF2B5EF4-FFF2-40B4-BE49-F238E27FC236}">
              <a16:creationId xmlns:a16="http://schemas.microsoft.com/office/drawing/2014/main" id="{383CD3F7-4822-AD69-A250-051279628C3D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779752" y="2060997"/>
          <a:ext cx="951895" cy="438306"/>
        </a:xfrm>
        <a:prstGeom xmlns:a="http://schemas.openxmlformats.org/drawingml/2006/main" prst="curvedConnector3">
          <a:avLst/>
        </a:prstGeom>
        <a:ln xmlns:a="http://schemas.openxmlformats.org/drawingml/2006/main" w="28575">
          <a:solidFill>
            <a:srgbClr val="002060"/>
          </a:solidFill>
          <a:prstDash val="sysDash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3226</cdr:x>
      <cdr:y>0.25644</cdr:y>
    </cdr:from>
    <cdr:to>
      <cdr:x>0.627</cdr:x>
      <cdr:y>0.33847</cdr:y>
    </cdr:to>
    <cdr:cxnSp macro="">
      <cdr:nvCxnSpPr>
        <cdr:cNvPr id="2" name="Γραμμή σύνδεσης: Καμπύλη 1">
          <a:extLst xmlns:a="http://schemas.openxmlformats.org/drawingml/2006/main">
            <a:ext uri="{FF2B5EF4-FFF2-40B4-BE49-F238E27FC236}">
              <a16:creationId xmlns:a16="http://schemas.microsoft.com/office/drawing/2014/main" id="{383CD3F7-4822-AD69-A250-051279628C3D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488687" y="959556"/>
          <a:ext cx="1320554" cy="306942"/>
        </a:xfrm>
        <a:prstGeom xmlns:a="http://schemas.openxmlformats.org/drawingml/2006/main" prst="curvedConnector3">
          <a:avLst/>
        </a:prstGeom>
        <a:ln xmlns:a="http://schemas.openxmlformats.org/drawingml/2006/main" w="28575">
          <a:solidFill>
            <a:srgbClr val="002060"/>
          </a:solidFill>
          <a:prstDash val="sysDash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8957</cdr:x>
      <cdr:y>0.53951</cdr:y>
    </cdr:from>
    <cdr:to>
      <cdr:x>0.93597</cdr:x>
      <cdr:y>0.62177</cdr:y>
    </cdr:to>
    <cdr:sp macro="" textlink="">
      <cdr:nvSpPr>
        <cdr:cNvPr id="19" name="TextBox 11">
          <a:extLst xmlns:a="http://schemas.openxmlformats.org/drawingml/2006/main">
            <a:ext uri="{FF2B5EF4-FFF2-40B4-BE49-F238E27FC236}">
              <a16:creationId xmlns:a16="http://schemas.microsoft.com/office/drawing/2014/main" id="{1E76A1CC-3B12-567D-9DE2-20590F069795}"/>
            </a:ext>
          </a:extLst>
        </cdr:cNvPr>
        <cdr:cNvSpPr txBox="1"/>
      </cdr:nvSpPr>
      <cdr:spPr>
        <a:xfrm xmlns:a="http://schemas.openxmlformats.org/drawingml/2006/main">
          <a:off x="2641572" y="2018737"/>
          <a:ext cx="1552028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l-G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400" b="1" dirty="0">
              <a:solidFill>
                <a:srgbClr val="002060"/>
              </a:solidFill>
              <a:latin typeface="Arial" panose="020B0604020202020204" pitchFamily="34" charset="0"/>
              <a:cs typeface="Arial" panose="020B0604020202020204" pitchFamily="34" charset="0"/>
            </a:rPr>
            <a:t>CONCLUSIONS</a:t>
          </a:r>
          <a:r>
            <a:rPr lang="en-US" sz="1400" dirty="0"/>
            <a:t> </a:t>
          </a:r>
          <a:endParaRPr lang="el-GR" sz="1400" dirty="0"/>
        </a:p>
      </cdr:txBody>
    </cdr:sp>
  </cdr:relSizeAnchor>
  <cdr:relSizeAnchor xmlns:cdr="http://schemas.openxmlformats.org/drawingml/2006/chartDrawing">
    <cdr:from>
      <cdr:x>0.10885</cdr:x>
      <cdr:y>0.57263</cdr:y>
    </cdr:from>
    <cdr:to>
      <cdr:x>0.3732</cdr:x>
      <cdr:y>0.66311</cdr:y>
    </cdr:to>
    <cdr:sp macro="" textlink="">
      <cdr:nvSpPr>
        <cdr:cNvPr id="21" name="TextBox 1035">
          <a:extLst xmlns:a="http://schemas.openxmlformats.org/drawingml/2006/main">
            <a:ext uri="{FF2B5EF4-FFF2-40B4-BE49-F238E27FC236}">
              <a16:creationId xmlns:a16="http://schemas.microsoft.com/office/drawing/2014/main" id="{1D44EDDB-BE65-F556-8ABA-D184950FD60B}"/>
            </a:ext>
          </a:extLst>
        </cdr:cNvPr>
        <cdr:cNvSpPr txBox="1"/>
      </cdr:nvSpPr>
      <cdr:spPr>
        <a:xfrm xmlns:a="http://schemas.openxmlformats.org/drawingml/2006/main">
          <a:off x="487685" y="2142661"/>
          <a:ext cx="1184427" cy="33855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l-G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dirty="0">
              <a:latin typeface="Arial" panose="020B0604020202020204" pitchFamily="34" charset="0"/>
              <a:cs typeface="Arial" panose="020B0604020202020204" pitchFamily="34" charset="0"/>
            </a:rPr>
            <a:t>Vitamin D  </a:t>
          </a:r>
          <a:endParaRPr lang="el-GR" sz="16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3308</cdr:x>
      <cdr:y>0.71234</cdr:y>
    </cdr:from>
    <cdr:to>
      <cdr:x>0.60296</cdr:x>
      <cdr:y>0.76311</cdr:y>
    </cdr:to>
    <cdr:cxnSp macro="">
      <cdr:nvCxnSpPr>
        <cdr:cNvPr id="22" name="Γραμμή σύνδεσης: Καμπύλη 21">
          <a:extLst xmlns:a="http://schemas.openxmlformats.org/drawingml/2006/main">
            <a:ext uri="{FF2B5EF4-FFF2-40B4-BE49-F238E27FC236}">
              <a16:creationId xmlns:a16="http://schemas.microsoft.com/office/drawing/2014/main" id="{294C5EBA-7D11-E28F-0BEB-C8A0A0728386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492370" y="2665412"/>
          <a:ext cx="1209183" cy="189981"/>
        </a:xfrm>
        <a:prstGeom xmlns:a="http://schemas.openxmlformats.org/drawingml/2006/main" prst="curvedConnector3">
          <a:avLst/>
        </a:prstGeom>
        <a:ln xmlns:a="http://schemas.openxmlformats.org/drawingml/2006/main" w="28575">
          <a:solidFill>
            <a:srgbClr val="002060"/>
          </a:solidFill>
          <a:prstDash val="sysDash"/>
          <a:tailEnd type="triangle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59865</cdr:x>
      <cdr:y>0.00453</cdr:y>
    </cdr:from>
    <cdr:to>
      <cdr:x>1</cdr:x>
      <cdr:y>0.29686</cdr:y>
    </cdr:to>
    <cdr:sp macro="" textlink="">
      <cdr:nvSpPr>
        <cdr:cNvPr id="2" name="TextBox 51">
          <a:extLst xmlns:a="http://schemas.openxmlformats.org/drawingml/2006/main">
            <a:ext uri="{FF2B5EF4-FFF2-40B4-BE49-F238E27FC236}">
              <a16:creationId xmlns:a16="http://schemas.microsoft.com/office/drawing/2014/main" id="{8F4D9D33-8B7F-4BE6-0657-42B39BE5B270}"/>
            </a:ext>
          </a:extLst>
        </cdr:cNvPr>
        <cdr:cNvSpPr txBox="1"/>
      </cdr:nvSpPr>
      <cdr:spPr>
        <a:xfrm xmlns:a="http://schemas.openxmlformats.org/drawingml/2006/main">
          <a:off x="2497227" y="11446"/>
          <a:ext cx="1674203" cy="7386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l-GR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Personal use of vitamin D by GPs &amp; MS </a:t>
          </a:r>
          <a:endParaRPr lang="el-GR" sz="14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547385D-0543-8D5E-B01B-11FA4604FD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1CDA3FCE-5D61-4409-6F61-8E8DC13FBB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9D0B2E0-E5E1-D3F5-AFE8-D1DA72475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895A9B37-1A75-ABF2-5B5E-3480304F3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8BC36FA3-5023-6F89-25F3-2B967CCF1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73227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96FB964-95C0-E8FD-85BE-F9E9C84427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3C02A438-F96F-1127-5AD7-6BB20F6A4C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2A979A9-766D-16C9-5AD6-257BD9E3C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AE13A2B-0F13-4244-2561-7BA621298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28922B15-A8BF-4F8C-B57A-3AEA2AC0F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53390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74730A3D-8B72-ED86-9CF3-37F8AF2643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12021AEC-7804-746A-8EAF-99C0E0739E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B7886C2-D8CF-5A3B-C8A6-0606E62E0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94EAC2A-091F-2732-A6C2-6D6D86A43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AD1BC4D4-FD7F-615A-E3F8-10239817C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55821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0556821B-270B-4F90-19F6-05EF1895D9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B6A25E6C-0A34-1BB4-FFFB-68DE89FFA3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1233273C-A33D-B9B7-ACFB-BEC77E6C0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4D1DB24-1945-D538-4060-23A8492106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D270C61-C0B4-3EDA-AC80-6005708E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999321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A1C72933-1953-B138-BEFB-B081120C49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8E056740-0373-DF10-7CFB-B25D189A7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45A21459-2F79-27F6-EDB7-8F5535A7C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21C1FEBA-F5B3-C186-0F7C-4A608B146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E66E076A-CCDB-3455-3E30-3D0637BC4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96380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1C7C1F88-B526-47EF-63DB-84CCC183BE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3922AC61-772E-E15F-C0F9-BBF59D7B54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E0D19F3B-AF2B-B503-76E4-8899F2C8C8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E4AFD5E5-21AE-1227-0457-DF90C6552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A6141B7D-51D4-EF25-7989-F7C804B05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5B19F2A5-71B8-6C4A-3985-0128EEEAD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64949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76B9977-63C5-43C4-660B-C0CD9457D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9B9A7C58-A28E-73D7-A7AB-1FBD68C1A9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5C539D67-5B13-AB2F-C549-038CC948F4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DB9E5741-8FB7-D84D-C002-BA1C0AF515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729FACE8-DC5F-B72B-1167-81E2395C48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25D02ADC-79A3-7C40-7DA0-8F86E53C3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571B8F9F-B930-553A-4149-A502CC9B4B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DB8DF3BA-C2E2-1037-00DE-814200A6FB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30214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E3C6E96D-7197-A425-4987-DA7A1DD95A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71F3C417-C46D-D69E-E3A8-F53DBD7A3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BC298257-0A19-D1BB-5135-9933818E1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18880FA1-CFBD-9F73-F1D2-2DCCED3C7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11279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75DF2247-CB35-0C66-3900-AE8719A37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5423A0D2-8ED1-D94F-88AE-E147769F9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68051672-7FD9-D72F-DF4D-77BB43DDF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60544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1FC575BA-F80A-3C37-AD49-36F395A565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2B250782-655D-8D71-2DEA-2A59F2C497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6D9D3FD8-295B-2898-750C-7988CE1176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57826CFC-05F5-95E7-B386-800EE7E067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4CC165FC-D079-1712-44E1-C45AFF493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CDF5C43B-1247-2308-19E8-ECA98FEE1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40014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2299456E-FE20-FEED-F6F2-6C8EB15174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A0ACBE3F-812B-DFC4-7836-9196A25E80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7ED6772D-5721-C0A1-31A3-B9776DB9CC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0B905A91-3D2D-00E4-573B-3394192D1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530FF99F-957F-922F-BA2F-6A59C594B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2877F95C-E07A-8F30-F5BB-D52B9339A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3700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4862A662-27AA-B63B-55C1-ED3CE982F1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98FA1EF6-FF0D-B6A1-B0DF-19E55B0559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89D7835E-E450-D8E3-609A-93AD4BC5F7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0EEA1-0AFE-4F4C-9AEE-03B452A3948E}" type="datetimeFigureOut">
              <a:rPr lang="el-GR" smtClean="0"/>
              <a:t>13/5/2022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A6657B1A-0FB0-30EF-68A7-5CC7E4D983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026DA291-30ED-25AC-E312-2A6EE66BAF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41042-30F3-4DAF-9DF9-81F54461A3BB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888446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chart" Target="../charts/chart2.xml"/><Relationship Id="rId18" Type="http://schemas.openxmlformats.org/officeDocument/2006/relationships/image" Target="../media/image11.png"/><Relationship Id="rId3" Type="http://schemas.openxmlformats.org/officeDocument/2006/relationships/image" Target="../media/image2.svg"/><Relationship Id="rId7" Type="http://schemas.openxmlformats.org/officeDocument/2006/relationships/image" Target="../media/image6.jpeg"/><Relationship Id="rId12" Type="http://schemas.openxmlformats.org/officeDocument/2006/relationships/chart" Target="../charts/chart1.xml"/><Relationship Id="rId17" Type="http://schemas.openxmlformats.org/officeDocument/2006/relationships/chart" Target="../charts/chart6.xml"/><Relationship Id="rId2" Type="http://schemas.openxmlformats.org/officeDocument/2006/relationships/image" Target="../media/image1.png"/><Relationship Id="rId16" Type="http://schemas.openxmlformats.org/officeDocument/2006/relationships/chart" Target="../charts/chart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5" Type="http://schemas.openxmlformats.org/officeDocument/2006/relationships/chart" Target="../charts/chart4.xml"/><Relationship Id="rId10" Type="http://schemas.openxmlformats.org/officeDocument/2006/relationships/image" Target="../media/image9.png"/><Relationship Id="rId19" Type="http://schemas.openxmlformats.org/officeDocument/2006/relationships/image" Target="../media/image12.svg"/><Relationship Id="rId4" Type="http://schemas.openxmlformats.org/officeDocument/2006/relationships/image" Target="../media/image3.png"/><Relationship Id="rId9" Type="http://schemas.openxmlformats.org/officeDocument/2006/relationships/image" Target="../media/image8.svg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Γραφικό 4" descr="Κτηνίατρος">
            <a:extLst>
              <a:ext uri="{FF2B5EF4-FFF2-40B4-BE49-F238E27FC236}">
                <a16:creationId xmlns:a16="http://schemas.microsoft.com/office/drawing/2014/main" id="{CD0096BB-49BB-7BE4-C5D0-970DF35E9E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88139" y="1529114"/>
            <a:ext cx="1342747" cy="1342747"/>
          </a:xfrm>
          <a:prstGeom prst="rect">
            <a:avLst/>
          </a:prstGeom>
        </p:spPr>
      </p:pic>
      <p:pic>
        <p:nvPicPr>
          <p:cNvPr id="9" name="Γραφικό 8" descr="Μολύβι">
            <a:extLst>
              <a:ext uri="{FF2B5EF4-FFF2-40B4-BE49-F238E27FC236}">
                <a16:creationId xmlns:a16="http://schemas.microsoft.com/office/drawing/2014/main" id="{A011910D-DD1F-A233-09A3-F604084908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 rot="16831528">
            <a:off x="1077320" y="1888103"/>
            <a:ext cx="526002" cy="526002"/>
          </a:xfrm>
          <a:prstGeom prst="rect">
            <a:avLst/>
          </a:prstGeom>
        </p:spPr>
      </p:pic>
      <p:sp>
        <p:nvSpPr>
          <p:cNvPr id="10" name="Ορθογώνιο 9">
            <a:extLst>
              <a:ext uri="{FF2B5EF4-FFF2-40B4-BE49-F238E27FC236}">
                <a16:creationId xmlns:a16="http://schemas.microsoft.com/office/drawing/2014/main" id="{1F3CEF34-247E-FBBF-A1D4-FCD392CA4278}"/>
              </a:ext>
            </a:extLst>
          </p:cNvPr>
          <p:cNvSpPr/>
          <p:nvPr/>
        </p:nvSpPr>
        <p:spPr>
          <a:xfrm>
            <a:off x="0" y="0"/>
            <a:ext cx="10475650" cy="10287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Vitamin D prescribing practices amongst clinical practitioners during the COVID-19 pandemic</a:t>
            </a:r>
            <a:endParaRPr lang="el-GR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Εικόνα 10">
            <a:extLst>
              <a:ext uri="{FF2B5EF4-FFF2-40B4-BE49-F238E27FC236}">
                <a16:creationId xmlns:a16="http://schemas.microsoft.com/office/drawing/2014/main" id="{10B1DF00-26DA-6D1D-DAD1-3EC3A63D967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475650" y="0"/>
            <a:ext cx="1716350" cy="10287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E76A1CC-3B12-567D-9DE2-20590F069795}"/>
              </a:ext>
            </a:extLst>
          </p:cNvPr>
          <p:cNvSpPr txBox="1"/>
          <p:nvPr/>
        </p:nvSpPr>
        <p:spPr>
          <a:xfrm>
            <a:off x="1340321" y="1037879"/>
            <a:ext cx="11224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r>
              <a:rPr lang="en-US" sz="1400" dirty="0"/>
              <a:t> </a:t>
            </a:r>
            <a:endParaRPr lang="el-GR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BDC934-4693-2600-6435-898597C8B262}"/>
              </a:ext>
            </a:extLst>
          </p:cNvPr>
          <p:cNvSpPr txBox="1"/>
          <p:nvPr/>
        </p:nvSpPr>
        <p:spPr>
          <a:xfrm>
            <a:off x="1260564" y="1517201"/>
            <a:ext cx="15183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Questionnaire 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2022B6F-1082-4A8E-669B-4AD57877FED6}"/>
              </a:ext>
            </a:extLst>
          </p:cNvPr>
          <p:cNvSpPr txBox="1"/>
          <p:nvPr/>
        </p:nvSpPr>
        <p:spPr>
          <a:xfrm>
            <a:off x="2592503" y="1409418"/>
            <a:ext cx="166904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Vitamin D 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rescribe 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ersonal use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392 Vitamin D Pills Illustrations &amp; Clip Art - iStock">
            <a:extLst>
              <a:ext uri="{FF2B5EF4-FFF2-40B4-BE49-F238E27FC236}">
                <a16:creationId xmlns:a16="http://schemas.microsoft.com/office/drawing/2014/main" id="{30273C98-FCE5-E32F-19D8-92D6D507EE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2205" y="2243805"/>
            <a:ext cx="780855" cy="7808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6" name="Γραμμή σύνδεσης: Καμπύλη 15">
            <a:extLst>
              <a:ext uri="{FF2B5EF4-FFF2-40B4-BE49-F238E27FC236}">
                <a16:creationId xmlns:a16="http://schemas.microsoft.com/office/drawing/2014/main" id="{383CD3F7-4822-AD69-A250-051279628C3D}"/>
              </a:ext>
            </a:extLst>
          </p:cNvPr>
          <p:cNvCxnSpPr>
            <a:cxnSpLocks/>
          </p:cNvCxnSpPr>
          <p:nvPr/>
        </p:nvCxnSpPr>
        <p:spPr>
          <a:xfrm>
            <a:off x="3925481" y="1744151"/>
            <a:ext cx="617941" cy="499654"/>
          </a:xfrm>
          <a:prstGeom prst="curvedConnector3">
            <a:avLst/>
          </a:prstGeom>
          <a:ln w="28575">
            <a:solidFill>
              <a:srgbClr val="002060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C52D7E1-BDED-2375-AF88-9F0098CC5902}"/>
              </a:ext>
            </a:extLst>
          </p:cNvPr>
          <p:cNvSpPr txBox="1"/>
          <p:nvPr/>
        </p:nvSpPr>
        <p:spPr>
          <a:xfrm>
            <a:off x="4444980" y="1636397"/>
            <a:ext cx="15856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ata collection 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Γραφικό 19" descr="Λίστα ελέγχου RTL">
            <a:extLst>
              <a:ext uri="{FF2B5EF4-FFF2-40B4-BE49-F238E27FC236}">
                <a16:creationId xmlns:a16="http://schemas.microsoft.com/office/drawing/2014/main" id="{55374E50-7B8F-28AD-B808-21D5E62832A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1435860" y="1736314"/>
            <a:ext cx="914400" cy="914400"/>
          </a:xfrm>
          <a:prstGeom prst="rect">
            <a:avLst/>
          </a:prstGeom>
        </p:spPr>
      </p:pic>
      <p:pic>
        <p:nvPicPr>
          <p:cNvPr id="22" name="Γραφικό 21" descr="Ημερήσιο ημερολόγιο">
            <a:extLst>
              <a:ext uri="{FF2B5EF4-FFF2-40B4-BE49-F238E27FC236}">
                <a16:creationId xmlns:a16="http://schemas.microsoft.com/office/drawing/2014/main" id="{E0BCC0EB-FF79-74C2-045C-59AA715716F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4498247" y="1894359"/>
            <a:ext cx="780855" cy="78085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7BB95D6-8BC4-329A-7965-3F7A147AC586}"/>
              </a:ext>
            </a:extLst>
          </p:cNvPr>
          <p:cNvSpPr txBox="1"/>
          <p:nvPr/>
        </p:nvSpPr>
        <p:spPr>
          <a:xfrm>
            <a:off x="4196179" y="2528737"/>
            <a:ext cx="189982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January-13 February 2021 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F30DCF8-F82A-3539-A0EF-9A75D79BAC6D}"/>
              </a:ext>
            </a:extLst>
          </p:cNvPr>
          <p:cNvSpPr txBox="1"/>
          <p:nvPr/>
        </p:nvSpPr>
        <p:spPr>
          <a:xfrm>
            <a:off x="7995822" y="1039676"/>
            <a:ext cx="10497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n-US" sz="1400" dirty="0"/>
              <a:t> </a:t>
            </a:r>
            <a:endParaRPr lang="el-GR" sz="1400" dirty="0"/>
          </a:p>
        </p:txBody>
      </p:sp>
      <p:cxnSp>
        <p:nvCxnSpPr>
          <p:cNvPr id="27" name="Ευθεία γραμμή σύνδεσης 26">
            <a:extLst>
              <a:ext uri="{FF2B5EF4-FFF2-40B4-BE49-F238E27FC236}">
                <a16:creationId xmlns:a16="http://schemas.microsoft.com/office/drawing/2014/main" id="{A4042822-805E-A8AC-2960-D3239B7A6398}"/>
              </a:ext>
            </a:extLst>
          </p:cNvPr>
          <p:cNvCxnSpPr>
            <a:cxnSpLocks/>
          </p:cNvCxnSpPr>
          <p:nvPr/>
        </p:nvCxnSpPr>
        <p:spPr>
          <a:xfrm>
            <a:off x="6074145" y="1097351"/>
            <a:ext cx="517" cy="2016161"/>
          </a:xfrm>
          <a:prstGeom prst="line">
            <a:avLst/>
          </a:prstGeom>
          <a:ln w="38100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0" name="Γράφημα 29">
            <a:extLst>
              <a:ext uri="{FF2B5EF4-FFF2-40B4-BE49-F238E27FC236}">
                <a16:creationId xmlns:a16="http://schemas.microsoft.com/office/drawing/2014/main" id="{A4398DF3-1016-E9B2-A4FD-A1C7FA13883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49960198"/>
              </p:ext>
            </p:extLst>
          </p:nvPr>
        </p:nvGraphicFramePr>
        <p:xfrm>
          <a:off x="6084556" y="1378147"/>
          <a:ext cx="3068912" cy="1621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87F2A8D0-E44B-6FF1-D860-8C0D6C27A465}"/>
              </a:ext>
            </a:extLst>
          </p:cNvPr>
          <p:cNvSpPr txBox="1"/>
          <p:nvPr/>
        </p:nvSpPr>
        <p:spPr>
          <a:xfrm>
            <a:off x="8405211" y="1507559"/>
            <a:ext cx="2576346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ternational survey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4,440 practicing clinicians 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Ps: general practioners</a:t>
            </a:r>
          </a:p>
          <a:p>
            <a:pPr marL="285750" indent="-285750">
              <a:buFont typeface="Wingdings" panose="05000000000000000000" pitchFamily="2" charset="2"/>
              <a:buChar char="q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S: medical specialists</a:t>
            </a:r>
            <a:endParaRPr lang="el-G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Γραφικό 32" descr="Κτηνίατρος">
            <a:extLst>
              <a:ext uri="{FF2B5EF4-FFF2-40B4-BE49-F238E27FC236}">
                <a16:creationId xmlns:a16="http://schemas.microsoft.com/office/drawing/2014/main" id="{4F95B696-19A0-EE53-D4F7-0199E7CACC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8461" y="5638355"/>
            <a:ext cx="1342747" cy="1342747"/>
          </a:xfrm>
          <a:prstGeom prst="rect">
            <a:avLst/>
          </a:prstGeom>
        </p:spPr>
      </p:pic>
      <p:graphicFrame>
        <p:nvGraphicFramePr>
          <p:cNvPr id="36" name="Γράφημα 35">
            <a:extLst>
              <a:ext uri="{FF2B5EF4-FFF2-40B4-BE49-F238E27FC236}">
                <a16:creationId xmlns:a16="http://schemas.microsoft.com/office/drawing/2014/main" id="{4CBD1B35-8A5B-5DE2-9016-1D3FB91EFD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87314221"/>
              </p:ext>
            </p:extLst>
          </p:nvPr>
        </p:nvGraphicFramePr>
        <p:xfrm>
          <a:off x="414467" y="2741387"/>
          <a:ext cx="2968592" cy="30787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42" name="Γράφημα 41">
            <a:extLst>
              <a:ext uri="{FF2B5EF4-FFF2-40B4-BE49-F238E27FC236}">
                <a16:creationId xmlns:a16="http://schemas.microsoft.com/office/drawing/2014/main" id="{2CF335DE-56AA-9F66-9FF7-B137B187C89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3399653"/>
              </p:ext>
            </p:extLst>
          </p:nvPr>
        </p:nvGraphicFramePr>
        <p:xfrm>
          <a:off x="-63402" y="2186997"/>
          <a:ext cx="4113007" cy="33210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45" name="Γράφημα 44">
            <a:extLst>
              <a:ext uri="{FF2B5EF4-FFF2-40B4-BE49-F238E27FC236}">
                <a16:creationId xmlns:a16="http://schemas.microsoft.com/office/drawing/2014/main" id="{55EE517C-9E57-1623-1BE8-DA6F8CF0811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08655036"/>
              </p:ext>
            </p:extLst>
          </p:nvPr>
        </p:nvGraphicFramePr>
        <p:xfrm>
          <a:off x="1635739" y="3515052"/>
          <a:ext cx="4480478" cy="37417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51" name="Γράφημα 50">
            <a:extLst>
              <a:ext uri="{FF2B5EF4-FFF2-40B4-BE49-F238E27FC236}">
                <a16:creationId xmlns:a16="http://schemas.microsoft.com/office/drawing/2014/main" id="{DEAC139B-E30C-F304-2552-F18BDC87AAE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090437620"/>
              </p:ext>
            </p:extLst>
          </p:nvPr>
        </p:nvGraphicFramePr>
        <p:xfrm>
          <a:off x="3502767" y="3165606"/>
          <a:ext cx="3834709" cy="25950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8F4D9D33-8B7F-4BE6-0657-42B39BE5B270}"/>
              </a:ext>
            </a:extLst>
          </p:cNvPr>
          <p:cNvSpPr txBox="1"/>
          <p:nvPr/>
        </p:nvSpPr>
        <p:spPr>
          <a:xfrm>
            <a:off x="4604331" y="3910190"/>
            <a:ext cx="165827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escription of vitamin D between GPs</a:t>
            </a:r>
            <a:endParaRPr lang="el-G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" name="Γράφημα 54">
            <a:extLst>
              <a:ext uri="{FF2B5EF4-FFF2-40B4-BE49-F238E27FC236}">
                <a16:creationId xmlns:a16="http://schemas.microsoft.com/office/drawing/2014/main" id="{45F52E59-35EB-7DF5-EE61-7C56F8ED267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81179148"/>
              </p:ext>
            </p:extLst>
          </p:nvPr>
        </p:nvGraphicFramePr>
        <p:xfrm>
          <a:off x="7010469" y="3037761"/>
          <a:ext cx="4171430" cy="25268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cxnSp>
        <p:nvCxnSpPr>
          <p:cNvPr id="58" name="Ευθεία γραμμή σύνδεσης 57">
            <a:extLst>
              <a:ext uri="{FF2B5EF4-FFF2-40B4-BE49-F238E27FC236}">
                <a16:creationId xmlns:a16="http://schemas.microsoft.com/office/drawing/2014/main" id="{B9487F81-1444-AC84-2B91-E4F46F64B63A}"/>
              </a:ext>
            </a:extLst>
          </p:cNvPr>
          <p:cNvCxnSpPr>
            <a:cxnSpLocks/>
          </p:cNvCxnSpPr>
          <p:nvPr/>
        </p:nvCxnSpPr>
        <p:spPr>
          <a:xfrm>
            <a:off x="88139" y="3079061"/>
            <a:ext cx="6018004" cy="34451"/>
          </a:xfrm>
          <a:prstGeom prst="line">
            <a:avLst/>
          </a:prstGeom>
          <a:ln w="412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Ευθεία γραμμή σύνδεσης 67">
            <a:extLst>
              <a:ext uri="{FF2B5EF4-FFF2-40B4-BE49-F238E27FC236}">
                <a16:creationId xmlns:a16="http://schemas.microsoft.com/office/drawing/2014/main" id="{D8EE28F4-FCE8-3339-C985-62C39B64821D}"/>
              </a:ext>
            </a:extLst>
          </p:cNvPr>
          <p:cNvCxnSpPr>
            <a:cxnSpLocks/>
          </p:cNvCxnSpPr>
          <p:nvPr/>
        </p:nvCxnSpPr>
        <p:spPr>
          <a:xfrm flipV="1">
            <a:off x="0" y="5514876"/>
            <a:ext cx="12192000" cy="19358"/>
          </a:xfrm>
          <a:prstGeom prst="line">
            <a:avLst/>
          </a:prstGeom>
          <a:ln w="412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Γραμμή σύνδεσης: Καμπύλη 71">
            <a:extLst>
              <a:ext uri="{FF2B5EF4-FFF2-40B4-BE49-F238E27FC236}">
                <a16:creationId xmlns:a16="http://schemas.microsoft.com/office/drawing/2014/main" id="{294C5EBA-7D11-E28F-0BEB-C8A0A0728386}"/>
              </a:ext>
            </a:extLst>
          </p:cNvPr>
          <p:cNvCxnSpPr>
            <a:cxnSpLocks/>
          </p:cNvCxnSpPr>
          <p:nvPr/>
        </p:nvCxnSpPr>
        <p:spPr>
          <a:xfrm>
            <a:off x="1180379" y="6370445"/>
            <a:ext cx="1010371" cy="295948"/>
          </a:xfrm>
          <a:prstGeom prst="curvedConnector3">
            <a:avLst/>
          </a:prstGeom>
          <a:ln w="28575">
            <a:solidFill>
              <a:srgbClr val="002060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5" name="Γραφικό 1034" descr="Λίστα RTL">
            <a:extLst>
              <a:ext uri="{FF2B5EF4-FFF2-40B4-BE49-F238E27FC236}">
                <a16:creationId xmlns:a16="http://schemas.microsoft.com/office/drawing/2014/main" id="{B4AF71D1-AF75-01EB-1ADE-DCB259B87E4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2180676" y="5943600"/>
            <a:ext cx="914400" cy="914400"/>
          </a:xfrm>
          <a:prstGeom prst="rect">
            <a:avLst/>
          </a:prstGeom>
        </p:spPr>
      </p:pic>
      <p:sp>
        <p:nvSpPr>
          <p:cNvPr id="1036" name="TextBox 1035">
            <a:extLst>
              <a:ext uri="{FF2B5EF4-FFF2-40B4-BE49-F238E27FC236}">
                <a16:creationId xmlns:a16="http://schemas.microsoft.com/office/drawing/2014/main" id="{1D44EDDB-BE65-F556-8ABA-D184950FD60B}"/>
              </a:ext>
            </a:extLst>
          </p:cNvPr>
          <p:cNvSpPr txBox="1"/>
          <p:nvPr/>
        </p:nvSpPr>
        <p:spPr>
          <a:xfrm>
            <a:off x="1131149" y="6080979"/>
            <a:ext cx="11079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rescribe 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266373B-9248-1FA5-6E9B-5F9895334B20}"/>
              </a:ext>
            </a:extLst>
          </p:cNvPr>
          <p:cNvSpPr txBox="1"/>
          <p:nvPr/>
        </p:nvSpPr>
        <p:spPr>
          <a:xfrm>
            <a:off x="4730246" y="5774065"/>
            <a:ext cx="6138358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 algn="just">
              <a:buFont typeface="Wingdings" panose="05000000000000000000" pitchFamily="2" charset="2"/>
              <a:buChar char="q"/>
            </a:pPr>
            <a:r>
              <a:rPr lang="el-GR" sz="16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y clinicians would prescribe vitamin D for the prevention and treatment of COVID-19.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 typeface="Wingdings" panose="05000000000000000000" pitchFamily="2" charset="2"/>
              <a:buChar char="q"/>
            </a:pP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The majority would also recommend measuring vitamin D levels, but not so in patients with COVID-19.</a:t>
            </a:r>
            <a:endParaRPr lang="el-G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6321704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92</Words>
  <Application>Microsoft Office PowerPoint</Application>
  <PresentationFormat>Ευρεία οθόνη</PresentationFormat>
  <Paragraphs>20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ΑΝΑΣΤΑΣΙΟΥ ΙΩΑΝΝΑ</dc:creator>
  <cp:lastModifiedBy>Nikolaos Tentolouris</cp:lastModifiedBy>
  <cp:revision>5</cp:revision>
  <dcterms:created xsi:type="dcterms:W3CDTF">2022-05-12T13:38:46Z</dcterms:created>
  <dcterms:modified xsi:type="dcterms:W3CDTF">2022-05-13T17:00:27Z</dcterms:modified>
</cp:coreProperties>
</file>